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8" r:id="rId5"/>
    <p:sldId id="259" r:id="rId6"/>
    <p:sldId id="262" r:id="rId7"/>
    <p:sldId id="260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4E29982-A364-4CDB-907D-F1E0A4CB11C0}" v="2" dt="2022-02-21T22:04:10.609"/>
    <p1510:client id="{5BEA0D15-6200-4C88-BD08-5D9669799DDD}" v="1" dt="2022-02-19T15:59:46.751"/>
    <p1510:client id="{75128EEC-3C06-4B2A-919F-EE76D84A7162}" v="3" dt="2022-02-19T15:50:03.9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10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68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ikel, Rebekah (NIH/NHGRI) [E]" userId="S::waikelrl@nih.gov::20c0d6a4-60db-4ce1-ae9d-87c5ec5746be" providerId="AD" clId="Web-{75128EEC-3C06-4B2A-919F-EE76D84A7162}"/>
    <pc:docChg chg="modSld">
      <pc:chgData name="Waikel, Rebekah (NIH/NHGRI) [E]" userId="S::waikelrl@nih.gov::20c0d6a4-60db-4ce1-ae9d-87c5ec5746be" providerId="AD" clId="Web-{75128EEC-3C06-4B2A-919F-EE76D84A7162}" dt="2022-02-19T15:50:01.512" v="1" actId="20577"/>
      <pc:docMkLst>
        <pc:docMk/>
      </pc:docMkLst>
      <pc:sldChg chg="modSp">
        <pc:chgData name="Waikel, Rebekah (NIH/NHGRI) [E]" userId="S::waikelrl@nih.gov::20c0d6a4-60db-4ce1-ae9d-87c5ec5746be" providerId="AD" clId="Web-{75128EEC-3C06-4B2A-919F-EE76D84A7162}" dt="2022-02-19T15:50:01.512" v="1" actId="20577"/>
        <pc:sldMkLst>
          <pc:docMk/>
          <pc:sldMk cId="1390423892" sldId="258"/>
        </pc:sldMkLst>
        <pc:spChg chg="mod">
          <ac:chgData name="Waikel, Rebekah (NIH/NHGRI) [E]" userId="S::waikelrl@nih.gov::20c0d6a4-60db-4ce1-ae9d-87c5ec5746be" providerId="AD" clId="Web-{75128EEC-3C06-4B2A-919F-EE76D84A7162}" dt="2022-02-19T15:50:01.512" v="1" actId="20577"/>
          <ac:spMkLst>
            <pc:docMk/>
            <pc:sldMk cId="1390423892" sldId="258"/>
            <ac:spMk id="13" creationId="{E54BA7A5-693F-44B3-A82A-A5E4DE7D8E6C}"/>
          </ac:spMkLst>
        </pc:spChg>
      </pc:sldChg>
    </pc:docChg>
  </pc:docChgLst>
  <pc:docChgLst>
    <pc:chgData name="Waikel, Rebekah (NIH/NHGRI) [E]" userId="S::waikelrl@nih.gov::20c0d6a4-60db-4ce1-ae9d-87c5ec5746be" providerId="AD" clId="Web-{5BEA0D15-6200-4C88-BD08-5D9669799DDD}"/>
    <pc:docChg chg="modSld">
      <pc:chgData name="Waikel, Rebekah (NIH/NHGRI) [E]" userId="S::waikelrl@nih.gov::20c0d6a4-60db-4ce1-ae9d-87c5ec5746be" providerId="AD" clId="Web-{5BEA0D15-6200-4C88-BD08-5D9669799DDD}" dt="2022-02-19T15:59:46.751" v="0"/>
      <pc:docMkLst>
        <pc:docMk/>
      </pc:docMkLst>
      <pc:sldChg chg="delSp">
        <pc:chgData name="Waikel, Rebekah (NIH/NHGRI) [E]" userId="S::waikelrl@nih.gov::20c0d6a4-60db-4ce1-ae9d-87c5ec5746be" providerId="AD" clId="Web-{5BEA0D15-6200-4C88-BD08-5D9669799DDD}" dt="2022-02-19T15:59:46.751" v="0"/>
        <pc:sldMkLst>
          <pc:docMk/>
          <pc:sldMk cId="2025436866" sldId="263"/>
        </pc:sldMkLst>
        <pc:spChg chg="del">
          <ac:chgData name="Waikel, Rebekah (NIH/NHGRI) [E]" userId="S::waikelrl@nih.gov::20c0d6a4-60db-4ce1-ae9d-87c5ec5746be" providerId="AD" clId="Web-{5BEA0D15-6200-4C88-BD08-5D9669799DDD}" dt="2022-02-19T15:59:46.751" v="0"/>
          <ac:spMkLst>
            <pc:docMk/>
            <pc:sldMk cId="2025436866" sldId="263"/>
            <ac:spMk id="3" creationId="{3AC026DE-E622-4606-B574-8D803A9F44F8}"/>
          </ac:spMkLst>
        </pc:spChg>
      </pc:sldChg>
    </pc:docChg>
  </pc:docChgLst>
  <pc:docChgLst>
    <pc:chgData name="Waikel, Rebekah (NIH/NHGRI) [E]" userId="S::waikelrl@nih.gov::20c0d6a4-60db-4ce1-ae9d-87c5ec5746be" providerId="AD" clId="Web-{24E29982-A364-4CDB-907D-F1E0A4CB11C0}"/>
    <pc:docChg chg="modSld">
      <pc:chgData name="Waikel, Rebekah (NIH/NHGRI) [E]" userId="S::waikelrl@nih.gov::20c0d6a4-60db-4ce1-ae9d-87c5ec5746be" providerId="AD" clId="Web-{24E29982-A364-4CDB-907D-F1E0A4CB11C0}" dt="2022-02-21T22:04:10.609" v="1" actId="20577"/>
      <pc:docMkLst>
        <pc:docMk/>
      </pc:docMkLst>
      <pc:sldChg chg="modSp">
        <pc:chgData name="Waikel, Rebekah (NIH/NHGRI) [E]" userId="S::waikelrl@nih.gov::20c0d6a4-60db-4ce1-ae9d-87c5ec5746be" providerId="AD" clId="Web-{24E29982-A364-4CDB-907D-F1E0A4CB11C0}" dt="2022-02-21T22:04:10.609" v="1" actId="20577"/>
        <pc:sldMkLst>
          <pc:docMk/>
          <pc:sldMk cId="1390423892" sldId="258"/>
        </pc:sldMkLst>
        <pc:spChg chg="mod">
          <ac:chgData name="Waikel, Rebekah (NIH/NHGRI) [E]" userId="S::waikelrl@nih.gov::20c0d6a4-60db-4ce1-ae9d-87c5ec5746be" providerId="AD" clId="Web-{24E29982-A364-4CDB-907D-F1E0A4CB11C0}" dt="2022-02-21T22:04:10.609" v="1" actId="20577"/>
          <ac:spMkLst>
            <pc:docMk/>
            <pc:sldMk cId="1390423892" sldId="258"/>
            <ac:spMk id="13" creationId="{E54BA7A5-693F-44B3-A82A-A5E4DE7D8E6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776987-09A4-4377-A153-83DBD6D489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FD4608-FEFA-4A34-90FA-02D8355695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EA055B-2F35-4567-B4F9-BC8036323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636118-5D7D-49C7-B81D-E60D66C40F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F9D474-8379-4981-A4B9-CAC0801361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141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B36958-9446-4FAD-8C10-95C34AF32F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8E8D9E-154D-4554-9ABA-A585BF848E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14B4DF-4DB7-4F1D-889A-C2B7586C3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002DF2-8F2F-4FAD-909E-FC16143D4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96006E-B3C5-4E2F-95EC-865DFE297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069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5838385-9FBB-4B93-8EB3-A59FE39FE3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BFBEFA-5B89-4C39-B347-22F119A5B4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E58785-94BB-424E-86C8-CE6B53943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395D6C-4345-478B-953D-E14BF6C6B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3840BD-EDB1-4A26-8D48-ED48343A0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686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2EE62A-C21B-4AE7-88AB-A7821B4D8E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140A84-BFE2-4247-96DE-81ACB6CF38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93986F-A03B-49D0-A770-7F78D88DA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CB09A-DF7A-4168-8485-EB9C2783A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430922-8D26-4B44-8194-8259591BD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281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3B3EF-4624-45B1-8BF7-34D06F979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F54A7B-BF92-4F6E-B585-C23630645E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F27DA5-B551-47AC-AC62-A309A6A82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DC095F-7854-4951-A601-DCDABAD58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98D1EF-0C65-47D7-BB3C-E0D6B3E17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175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09DE88-8CC6-4DBF-90EF-F36FDA7153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852558-765D-49B3-A573-04B83D6BAC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C315EC-CFB2-4E6E-9BC7-00C27B4FF0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4FA303-2885-44C6-ABAB-C7F126B8F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27A4B0-D37A-4F1E-85CD-FEB776935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08A3AB-B3B0-4A25-8B20-19891437D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096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A89F6-9AD3-4E57-944D-4F9A64921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8416FC-5CF8-4910-8793-71203A1D29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05EEFD-78A0-4A71-96C7-B58E438E25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EEA715D-332E-4416-8CB0-77B12CA1E3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1CA763-7641-47BA-A7EE-9C00A5725C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BDDEE6D-88B7-4D93-9B0A-1B07A4672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15C4A7-BD11-4D7A-BC4F-85BB1D945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E4978E7-CBB2-4B44-BEF9-B436AFC4A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36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89892A-40C2-4B4C-AFD3-BCBA6AB5D9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246E05-035A-4D89-9CC1-5B9E3C5D4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7B9222-5476-4C1E-B90C-28E50CC2A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A612F1-9801-46B3-9A6C-E99118145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121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D70321-2514-4DAF-8940-428712EF17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3DCD6CA-BC4F-486D-BC56-FB38AC21E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B25EA6-DA71-4BA6-BF34-9EBC35EB3F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162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8042C-C5ED-4FDF-8288-649CCA752B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23120D-5A7C-4FC2-A74F-1A5DAC8DBF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A3499C-8355-4B7B-A727-AAFB7F14A3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125071-F349-45E2-95B3-F16235B3A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3957F1-139C-48E3-B002-0655CAF60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2FD842-CA04-44B2-B596-319B52397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541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6CBC1C-8538-45E7-9CD2-8853BF8391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EF6F60-28BF-42EA-8E5C-5175D6CD8C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196E34-B69E-4BF2-8E50-DFE0D1E6BE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90EA27-7226-49B9-8BB9-165BCE11A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6C2E7D-4095-47E6-A891-3BAF300FB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9FAAF3-4E6D-46B3-94DA-711407C47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894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CA5C55B-96DA-4AB7-BFCC-2F80C3CF2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96C5D7-7CF0-4C66-906B-9BB40147BF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75353B-AA97-412F-B56D-F18967F16F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2BCE9E-36F6-47F3-B9C3-A189F57340E0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EA048E-B0FF-44E2-A96E-DCEBB85A68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1C9465-832B-4310-B103-C042615432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4B3E0-0905-4D71-91BE-1850DE083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62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, waterfall chart&#10;&#10;Description automatically generated">
            <a:extLst>
              <a:ext uri="{FF2B5EF4-FFF2-40B4-BE49-F238E27FC236}">
                <a16:creationId xmlns:a16="http://schemas.microsoft.com/office/drawing/2014/main" id="{607D6984-4F44-4B4E-8DAD-6AF48F06A1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8195" y="1026923"/>
            <a:ext cx="5325285" cy="532528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BCD3CC4-A4AA-4D04-B3F7-2ED65148714B}"/>
              </a:ext>
            </a:extLst>
          </p:cNvPr>
          <p:cNvSpPr txBox="1"/>
          <p:nvPr/>
        </p:nvSpPr>
        <p:spPr>
          <a:xfrm rot="16200000">
            <a:off x="1861129" y="1968943"/>
            <a:ext cx="1062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22q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48874B-81D3-40D5-B09A-233794E65AD5}"/>
              </a:ext>
            </a:extLst>
          </p:cNvPr>
          <p:cNvSpPr txBox="1"/>
          <p:nvPr/>
        </p:nvSpPr>
        <p:spPr>
          <a:xfrm rot="16200000">
            <a:off x="1759530" y="293572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1E1F76-2F08-4746-9A3E-AAAB3A795724}"/>
              </a:ext>
            </a:extLst>
          </p:cNvPr>
          <p:cNvSpPr txBox="1"/>
          <p:nvPr/>
        </p:nvSpPr>
        <p:spPr>
          <a:xfrm rot="16200000">
            <a:off x="1866133" y="4190618"/>
            <a:ext cx="1200427" cy="346836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600"/>
              <a:t>  Unaffec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7C83A7-C8D9-4B6B-8185-828168596F33}"/>
              </a:ext>
            </a:extLst>
          </p:cNvPr>
          <p:cNvSpPr txBox="1"/>
          <p:nvPr/>
        </p:nvSpPr>
        <p:spPr>
          <a:xfrm rot="16200000">
            <a:off x="2037353" y="5116236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2EFA2B-094B-4594-B80F-0C23F8867091}"/>
              </a:ext>
            </a:extLst>
          </p:cNvPr>
          <p:cNvSpPr txBox="1"/>
          <p:nvPr/>
        </p:nvSpPr>
        <p:spPr>
          <a:xfrm>
            <a:off x="2762591" y="5927783"/>
            <a:ext cx="1062179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22q</a:t>
            </a:r>
          </a:p>
          <a:p>
            <a:pPr algn="ctr"/>
            <a:endParaRPr lang="en-US" sz="160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692A44B-5978-465B-9E9C-CB68E0F6BBC2}"/>
              </a:ext>
            </a:extLst>
          </p:cNvPr>
          <p:cNvSpPr txBox="1"/>
          <p:nvPr/>
        </p:nvSpPr>
        <p:spPr>
          <a:xfrm>
            <a:off x="3723173" y="592778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D9496B-0795-4D05-B8DB-B2229EB7CE3E}"/>
              </a:ext>
            </a:extLst>
          </p:cNvPr>
          <p:cNvSpPr txBox="1"/>
          <p:nvPr/>
        </p:nvSpPr>
        <p:spPr>
          <a:xfrm>
            <a:off x="4785352" y="5930092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Unaffected</a:t>
            </a:r>
          </a:p>
          <a:p>
            <a:pPr algn="ctr"/>
            <a:endParaRPr lang="en-US" sz="160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7EF2E5-8A16-4A9A-AD05-36EB465A7C58}"/>
              </a:ext>
            </a:extLst>
          </p:cNvPr>
          <p:cNvSpPr txBox="1"/>
          <p:nvPr/>
        </p:nvSpPr>
        <p:spPr>
          <a:xfrm>
            <a:off x="5976120" y="5927783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E54BA7A5-693F-44B3-A82A-A5E4DE7D8E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548226" y="2021997"/>
            <a:ext cx="2772253" cy="1407003"/>
          </a:xfrm>
        </p:spPr>
        <p:txBody>
          <a:bodyPr vert="horz" lIns="91440" tIns="45720" rIns="91440" bIns="45720" rtlCol="0" anchor="t">
            <a:noAutofit/>
          </a:bodyPr>
          <a:lstStyle/>
          <a:p>
            <a:pPr marL="0" indent="0">
              <a:buNone/>
            </a:pPr>
            <a:r>
              <a:rPr lang="en-US" sz="1200" b="1" dirty="0">
                <a:latin typeface="Times New Roman"/>
                <a:cs typeface="Times New Roman"/>
              </a:rPr>
              <a:t>Additional File 8.</a:t>
            </a:r>
            <a:r>
              <a:rPr lang="en-US" sz="1200" dirty="0">
                <a:latin typeface="Times New Roman"/>
                <a:cs typeface="Times New Roman"/>
              </a:rPr>
              <a:t> Confusion matrices of accuracy of classifier trained on real images and fake images.  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Accuracy is based on 50 test images of WS, 50 of 22q and 81 of other conditions. Fake images types include Type 1 (A), Type 2 (B), Type 3 (C), Type 4 </a:t>
            </a:r>
            <a:r>
              <a:rPr lang="en-US" sz="1200" dirty="0">
                <a:latin typeface="Times New Roman"/>
                <a:cs typeface="Times New Roman"/>
              </a:rPr>
              <a:t>where constant c=0.55 (D), and Type 4 where constant c=0.75 (E). </a:t>
            </a:r>
            <a:endParaRPr lang="en-US" sz="1200">
              <a:latin typeface="Times New Roman"/>
              <a:cs typeface="Calibri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C523D6D-3D07-403E-8814-771A0AF05481}"/>
              </a:ext>
            </a:extLst>
          </p:cNvPr>
          <p:cNvSpPr txBox="1"/>
          <p:nvPr/>
        </p:nvSpPr>
        <p:spPr>
          <a:xfrm>
            <a:off x="1765849" y="1269476"/>
            <a:ext cx="795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13904238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F4637F1C-CDD8-441F-82A7-AD4648D531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8195" y="1036659"/>
            <a:ext cx="5325285" cy="532528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BCD3CC4-A4AA-4D04-B3F7-2ED65148714B}"/>
              </a:ext>
            </a:extLst>
          </p:cNvPr>
          <p:cNvSpPr txBox="1"/>
          <p:nvPr/>
        </p:nvSpPr>
        <p:spPr>
          <a:xfrm rot="16200000">
            <a:off x="1861129" y="1968943"/>
            <a:ext cx="1062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22q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48874B-81D3-40D5-B09A-233794E65AD5}"/>
              </a:ext>
            </a:extLst>
          </p:cNvPr>
          <p:cNvSpPr txBox="1"/>
          <p:nvPr/>
        </p:nvSpPr>
        <p:spPr>
          <a:xfrm rot="16200000">
            <a:off x="1759530" y="293572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1E1F76-2F08-4746-9A3E-AAAB3A795724}"/>
              </a:ext>
            </a:extLst>
          </p:cNvPr>
          <p:cNvSpPr txBox="1"/>
          <p:nvPr/>
        </p:nvSpPr>
        <p:spPr>
          <a:xfrm rot="16200000">
            <a:off x="1866133" y="4190618"/>
            <a:ext cx="1200427" cy="346836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600"/>
              <a:t>  Unaffec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7C83A7-C8D9-4B6B-8185-828168596F33}"/>
              </a:ext>
            </a:extLst>
          </p:cNvPr>
          <p:cNvSpPr txBox="1"/>
          <p:nvPr/>
        </p:nvSpPr>
        <p:spPr>
          <a:xfrm rot="16200000">
            <a:off x="2037353" y="5116236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2EFA2B-094B-4594-B80F-0C23F8867091}"/>
              </a:ext>
            </a:extLst>
          </p:cNvPr>
          <p:cNvSpPr txBox="1"/>
          <p:nvPr/>
        </p:nvSpPr>
        <p:spPr>
          <a:xfrm>
            <a:off x="2762591" y="5927783"/>
            <a:ext cx="1062179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22q</a:t>
            </a:r>
          </a:p>
          <a:p>
            <a:pPr algn="ctr"/>
            <a:endParaRPr lang="en-US" sz="160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692A44B-5978-465B-9E9C-CB68E0F6BBC2}"/>
              </a:ext>
            </a:extLst>
          </p:cNvPr>
          <p:cNvSpPr txBox="1"/>
          <p:nvPr/>
        </p:nvSpPr>
        <p:spPr>
          <a:xfrm>
            <a:off x="3723173" y="592778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D9496B-0795-4D05-B8DB-B2229EB7CE3E}"/>
              </a:ext>
            </a:extLst>
          </p:cNvPr>
          <p:cNvSpPr txBox="1"/>
          <p:nvPr/>
        </p:nvSpPr>
        <p:spPr>
          <a:xfrm>
            <a:off x="4785352" y="5930092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Unaffected</a:t>
            </a:r>
          </a:p>
          <a:p>
            <a:pPr algn="ctr"/>
            <a:endParaRPr lang="en-US" sz="160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7EF2E5-8A16-4A9A-AD05-36EB465A7C58}"/>
              </a:ext>
            </a:extLst>
          </p:cNvPr>
          <p:cNvSpPr txBox="1"/>
          <p:nvPr/>
        </p:nvSpPr>
        <p:spPr>
          <a:xfrm>
            <a:off x="5976120" y="5927783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6B731EC-7919-4408-BBA3-4F98BBC7A523}"/>
              </a:ext>
            </a:extLst>
          </p:cNvPr>
          <p:cNvSpPr txBox="1"/>
          <p:nvPr/>
        </p:nvSpPr>
        <p:spPr>
          <a:xfrm>
            <a:off x="1765849" y="1269476"/>
            <a:ext cx="795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018323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Chart, waterfall chart&#10;&#10;Description automatically generated">
            <a:extLst>
              <a:ext uri="{FF2B5EF4-FFF2-40B4-BE49-F238E27FC236}">
                <a16:creationId xmlns:a16="http://schemas.microsoft.com/office/drawing/2014/main" id="{7140EA46-F7BD-45C2-85A1-5249180BF1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8195" y="1035864"/>
            <a:ext cx="5325285" cy="532528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BCD3CC4-A4AA-4D04-B3F7-2ED65148714B}"/>
              </a:ext>
            </a:extLst>
          </p:cNvPr>
          <p:cNvSpPr txBox="1"/>
          <p:nvPr/>
        </p:nvSpPr>
        <p:spPr>
          <a:xfrm rot="16200000">
            <a:off x="1861129" y="1968943"/>
            <a:ext cx="1062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22q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48874B-81D3-40D5-B09A-233794E65AD5}"/>
              </a:ext>
            </a:extLst>
          </p:cNvPr>
          <p:cNvSpPr txBox="1"/>
          <p:nvPr/>
        </p:nvSpPr>
        <p:spPr>
          <a:xfrm rot="16200000">
            <a:off x="1759530" y="293572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1E1F76-2F08-4746-9A3E-AAAB3A795724}"/>
              </a:ext>
            </a:extLst>
          </p:cNvPr>
          <p:cNvSpPr txBox="1"/>
          <p:nvPr/>
        </p:nvSpPr>
        <p:spPr>
          <a:xfrm rot="16200000">
            <a:off x="1866133" y="4190618"/>
            <a:ext cx="1200427" cy="346836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600"/>
              <a:t>  Unaffec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7C83A7-C8D9-4B6B-8185-828168596F33}"/>
              </a:ext>
            </a:extLst>
          </p:cNvPr>
          <p:cNvSpPr txBox="1"/>
          <p:nvPr/>
        </p:nvSpPr>
        <p:spPr>
          <a:xfrm rot="16200000">
            <a:off x="2037353" y="5116236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2EFA2B-094B-4594-B80F-0C23F8867091}"/>
              </a:ext>
            </a:extLst>
          </p:cNvPr>
          <p:cNvSpPr txBox="1"/>
          <p:nvPr/>
        </p:nvSpPr>
        <p:spPr>
          <a:xfrm>
            <a:off x="2762591" y="5927783"/>
            <a:ext cx="1062179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22q</a:t>
            </a:r>
          </a:p>
          <a:p>
            <a:pPr algn="ctr"/>
            <a:endParaRPr lang="en-US" sz="160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692A44B-5978-465B-9E9C-CB68E0F6BBC2}"/>
              </a:ext>
            </a:extLst>
          </p:cNvPr>
          <p:cNvSpPr txBox="1"/>
          <p:nvPr/>
        </p:nvSpPr>
        <p:spPr>
          <a:xfrm>
            <a:off x="3723173" y="592778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D9496B-0795-4D05-B8DB-B2229EB7CE3E}"/>
              </a:ext>
            </a:extLst>
          </p:cNvPr>
          <p:cNvSpPr txBox="1"/>
          <p:nvPr/>
        </p:nvSpPr>
        <p:spPr>
          <a:xfrm>
            <a:off x="4785352" y="5930092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Unaffected</a:t>
            </a:r>
          </a:p>
          <a:p>
            <a:pPr algn="ctr"/>
            <a:endParaRPr lang="en-US" sz="160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7EF2E5-8A16-4A9A-AD05-36EB465A7C58}"/>
              </a:ext>
            </a:extLst>
          </p:cNvPr>
          <p:cNvSpPr txBox="1"/>
          <p:nvPr/>
        </p:nvSpPr>
        <p:spPr>
          <a:xfrm>
            <a:off x="5976120" y="5927783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1BF8315-09F8-4174-8FA5-E746F8E9C7F7}"/>
              </a:ext>
            </a:extLst>
          </p:cNvPr>
          <p:cNvSpPr txBox="1"/>
          <p:nvPr/>
        </p:nvSpPr>
        <p:spPr>
          <a:xfrm>
            <a:off x="1765849" y="1269476"/>
            <a:ext cx="795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39236204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Chart, waterfall chart&#10;&#10;Description automatically generated">
            <a:extLst>
              <a:ext uri="{FF2B5EF4-FFF2-40B4-BE49-F238E27FC236}">
                <a16:creationId xmlns:a16="http://schemas.microsoft.com/office/drawing/2014/main" id="{E7767FDE-EFCE-47A5-8562-79AB002F25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8195" y="1032493"/>
            <a:ext cx="5325285" cy="532528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BCD3CC4-A4AA-4D04-B3F7-2ED65148714B}"/>
              </a:ext>
            </a:extLst>
          </p:cNvPr>
          <p:cNvSpPr txBox="1"/>
          <p:nvPr/>
        </p:nvSpPr>
        <p:spPr>
          <a:xfrm rot="16200000">
            <a:off x="1861129" y="1968943"/>
            <a:ext cx="1062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22q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48874B-81D3-40D5-B09A-233794E65AD5}"/>
              </a:ext>
            </a:extLst>
          </p:cNvPr>
          <p:cNvSpPr txBox="1"/>
          <p:nvPr/>
        </p:nvSpPr>
        <p:spPr>
          <a:xfrm rot="16200000">
            <a:off x="1759530" y="293572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1E1F76-2F08-4746-9A3E-AAAB3A795724}"/>
              </a:ext>
            </a:extLst>
          </p:cNvPr>
          <p:cNvSpPr txBox="1"/>
          <p:nvPr/>
        </p:nvSpPr>
        <p:spPr>
          <a:xfrm rot="16200000">
            <a:off x="1866133" y="4190618"/>
            <a:ext cx="1200427" cy="346836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600"/>
              <a:t>  Unaffec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7C83A7-C8D9-4B6B-8185-828168596F33}"/>
              </a:ext>
            </a:extLst>
          </p:cNvPr>
          <p:cNvSpPr txBox="1"/>
          <p:nvPr/>
        </p:nvSpPr>
        <p:spPr>
          <a:xfrm rot="16200000">
            <a:off x="2037353" y="5116236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2EFA2B-094B-4594-B80F-0C23F8867091}"/>
              </a:ext>
            </a:extLst>
          </p:cNvPr>
          <p:cNvSpPr txBox="1"/>
          <p:nvPr/>
        </p:nvSpPr>
        <p:spPr>
          <a:xfrm>
            <a:off x="2762591" y="5927783"/>
            <a:ext cx="1062179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22q</a:t>
            </a:r>
          </a:p>
          <a:p>
            <a:pPr algn="ctr"/>
            <a:endParaRPr lang="en-US" sz="160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692A44B-5978-465B-9E9C-CB68E0F6BBC2}"/>
              </a:ext>
            </a:extLst>
          </p:cNvPr>
          <p:cNvSpPr txBox="1"/>
          <p:nvPr/>
        </p:nvSpPr>
        <p:spPr>
          <a:xfrm>
            <a:off x="3723173" y="592778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D9496B-0795-4D05-B8DB-B2229EB7CE3E}"/>
              </a:ext>
            </a:extLst>
          </p:cNvPr>
          <p:cNvSpPr txBox="1"/>
          <p:nvPr/>
        </p:nvSpPr>
        <p:spPr>
          <a:xfrm>
            <a:off x="4785352" y="5930092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Unaffected</a:t>
            </a:r>
          </a:p>
          <a:p>
            <a:pPr algn="ctr"/>
            <a:endParaRPr lang="en-US" sz="160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7EF2E5-8A16-4A9A-AD05-36EB465A7C58}"/>
              </a:ext>
            </a:extLst>
          </p:cNvPr>
          <p:cNvSpPr txBox="1"/>
          <p:nvPr/>
        </p:nvSpPr>
        <p:spPr>
          <a:xfrm>
            <a:off x="5976120" y="5927783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599D2B9-4393-41C3-9A96-316F3BED880E}"/>
              </a:ext>
            </a:extLst>
          </p:cNvPr>
          <p:cNvSpPr txBox="1"/>
          <p:nvPr/>
        </p:nvSpPr>
        <p:spPr>
          <a:xfrm>
            <a:off x="1765849" y="1269476"/>
            <a:ext cx="795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30742025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F95FA008-C5DC-448E-AFC5-256897333F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1593" y="1032493"/>
            <a:ext cx="5325285" cy="532528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BCD3CC4-A4AA-4D04-B3F7-2ED65148714B}"/>
              </a:ext>
            </a:extLst>
          </p:cNvPr>
          <p:cNvSpPr txBox="1"/>
          <p:nvPr/>
        </p:nvSpPr>
        <p:spPr>
          <a:xfrm rot="16200000">
            <a:off x="1861129" y="1968943"/>
            <a:ext cx="1062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22q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48874B-81D3-40D5-B09A-233794E65AD5}"/>
              </a:ext>
            </a:extLst>
          </p:cNvPr>
          <p:cNvSpPr txBox="1"/>
          <p:nvPr/>
        </p:nvSpPr>
        <p:spPr>
          <a:xfrm rot="16200000">
            <a:off x="1759530" y="293572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1E1F76-2F08-4746-9A3E-AAAB3A795724}"/>
              </a:ext>
            </a:extLst>
          </p:cNvPr>
          <p:cNvSpPr txBox="1"/>
          <p:nvPr/>
        </p:nvSpPr>
        <p:spPr>
          <a:xfrm rot="16200000">
            <a:off x="1866133" y="4190618"/>
            <a:ext cx="1200427" cy="346836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600"/>
              <a:t>  Unaffec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7C83A7-C8D9-4B6B-8185-828168596F33}"/>
              </a:ext>
            </a:extLst>
          </p:cNvPr>
          <p:cNvSpPr txBox="1"/>
          <p:nvPr/>
        </p:nvSpPr>
        <p:spPr>
          <a:xfrm rot="16200000">
            <a:off x="2037353" y="5116236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2EFA2B-094B-4594-B80F-0C23F8867091}"/>
              </a:ext>
            </a:extLst>
          </p:cNvPr>
          <p:cNvSpPr txBox="1"/>
          <p:nvPr/>
        </p:nvSpPr>
        <p:spPr>
          <a:xfrm>
            <a:off x="2762591" y="5927783"/>
            <a:ext cx="1062179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22q</a:t>
            </a:r>
          </a:p>
          <a:p>
            <a:pPr algn="ctr"/>
            <a:endParaRPr lang="en-US" sz="160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692A44B-5978-465B-9E9C-CB68E0F6BBC2}"/>
              </a:ext>
            </a:extLst>
          </p:cNvPr>
          <p:cNvSpPr txBox="1"/>
          <p:nvPr/>
        </p:nvSpPr>
        <p:spPr>
          <a:xfrm>
            <a:off x="3723173" y="5927783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Other Condition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D9496B-0795-4D05-B8DB-B2229EB7CE3E}"/>
              </a:ext>
            </a:extLst>
          </p:cNvPr>
          <p:cNvSpPr txBox="1"/>
          <p:nvPr/>
        </p:nvSpPr>
        <p:spPr>
          <a:xfrm>
            <a:off x="4785352" y="5930092"/>
            <a:ext cx="1117601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Unaffected</a:t>
            </a:r>
          </a:p>
          <a:p>
            <a:pPr algn="ctr"/>
            <a:endParaRPr lang="en-US" sz="160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7EF2E5-8A16-4A9A-AD05-36EB465A7C58}"/>
              </a:ext>
            </a:extLst>
          </p:cNvPr>
          <p:cNvSpPr txBox="1"/>
          <p:nvPr/>
        </p:nvSpPr>
        <p:spPr>
          <a:xfrm>
            <a:off x="5976120" y="5927783"/>
            <a:ext cx="808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/>
              <a:t>W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ADD8A68-49AF-4248-8D0C-3E2CAE80A137}"/>
              </a:ext>
            </a:extLst>
          </p:cNvPr>
          <p:cNvSpPr txBox="1"/>
          <p:nvPr/>
        </p:nvSpPr>
        <p:spPr>
          <a:xfrm>
            <a:off x="1765849" y="1269476"/>
            <a:ext cx="795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.</a:t>
            </a:r>
          </a:p>
        </p:txBody>
      </p:sp>
    </p:spTree>
    <p:extLst>
      <p:ext uri="{BB962C8B-B14F-4D97-AF65-F5344CB8AC3E}">
        <p14:creationId xmlns:p14="http://schemas.microsoft.com/office/powerpoint/2010/main" val="2025436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8167CF01DBF90498E7A526AA8CF1A8C" ma:contentTypeVersion="9" ma:contentTypeDescription="Create a new document." ma:contentTypeScope="" ma:versionID="85033436ad1cb0adba3fb83f1ca9a00d">
  <xsd:schema xmlns:xsd="http://www.w3.org/2001/XMLSchema" xmlns:xs="http://www.w3.org/2001/XMLSchema" xmlns:p="http://schemas.microsoft.com/office/2006/metadata/properties" xmlns:ns2="8b25db39-86db-462c-bb85-f3ea4045ad49" xmlns:ns3="f4d5f980-7402-491b-a3c1-a3298e9cc04b" targetNamespace="http://schemas.microsoft.com/office/2006/metadata/properties" ma:root="true" ma:fieldsID="5012f291c9061c4eba65e332886de812" ns2:_="" ns3:_="">
    <xsd:import namespace="8b25db39-86db-462c-bb85-f3ea4045ad49"/>
    <xsd:import namespace="f4d5f980-7402-491b-a3c1-a3298e9cc04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25db39-86db-462c-bb85-f3ea4045ad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4d5f980-7402-491b-a3c1-a3298e9cc04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AA4A248-010F-4929-A563-4E6BD2A1558A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6550F6DB-0105-423F-B0A2-48557AE25D5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25db39-86db-462c-bb85-f3ea4045ad49"/>
    <ds:schemaRef ds:uri="f4d5f980-7402-491b-a3c1-a3298e9cc04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EDEAD37-3247-499B-A152-312C0BAF4E0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147</Words>
  <Application>Microsoft Office PowerPoint</Application>
  <PresentationFormat>Widescreen</PresentationFormat>
  <Paragraphs>4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fusion matrix</dc:title>
  <dc:creator>Duong, Dat (NIH/NHGRI) [E]</dc:creator>
  <cp:lastModifiedBy>Waikel, Rebekah (NIH/NHGRI) [E]</cp:lastModifiedBy>
  <cp:revision>20</cp:revision>
  <dcterms:created xsi:type="dcterms:W3CDTF">2021-12-30T19:51:02Z</dcterms:created>
  <dcterms:modified xsi:type="dcterms:W3CDTF">2022-02-22T23:33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8167CF01DBF90498E7A526AA8CF1A8C</vt:lpwstr>
  </property>
</Properties>
</file>